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263" r:id="rId3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73" d="100"/>
          <a:sy n="73" d="100"/>
        </p:scale>
        <p:origin x="6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67A279-CB12-45CF-8B5C-C3AA68545184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B37404-CE23-4C68-B773-841A5CD478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259163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64170-1E41-41E4-B24F-8DF66C3078E6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07792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D6FD0-45F6-4777-85CE-8244FBF03C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3B2740-DC49-49AE-85B9-87C8ABAFF6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F65BE5-76BF-4A10-B9FC-16BF4B843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259352-747A-4909-AC64-612660E58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E89643-E41A-4992-B0F8-514737222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763224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4C453-885D-490D-877F-A8E9C9380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7A49E9-70AD-48E7-B635-1AC9B18903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8BB30-E027-4D7E-8338-44E80D9A5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A0F623-C03F-43E9-8C51-A55AB70E4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2B619C-0732-431D-8B0C-1E1C61BA7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638615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A2EC6D-0790-4509-AEA6-861E1CE5B2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20B632-3E4E-4FA8-ABF5-89E409E37F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82579-8A31-4BA9-8ED5-EF1D9BB68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0A2489-6AC8-4EB6-AA7C-58FDF5BA0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CBC1E-12E4-4A97-89E8-0685E6A42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997198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6DB56-BE0A-41EF-910E-326957F9B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EED5E-816E-4E55-B008-5AC56700F0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B49FF-2AD4-45C3-811F-B54E90EB0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7EA058-BEC5-4DF9-829D-15906142B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E55006-E7B6-4B97-B4F6-0D76FD3F5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210431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BB3BE-F292-49AB-B28F-F76592398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547942-14A4-4C35-B79D-83A0D1515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382A94-95D6-4903-97A6-E8FB8952B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3E55DC-761C-4240-A412-F510ED265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986FD-8B38-4F8A-8C67-1B85D1940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184518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ACB44-B520-434B-AACA-10ABF7681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0A71A-913F-4E02-9E01-E26597487C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1184C6-3539-4A61-8884-EB45205DF1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3FF127-9684-428A-9977-9C88AB6BE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84EBC4-4680-4555-8423-3017B6EA1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4EE211-F8F6-4D12-B375-215FF7881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733758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ED592-B5AC-4FA9-9ABC-F57F3A444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41C01F-6D27-4C3D-92D4-9990FCB6A3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A2AF4C-150F-44FD-ACCF-36530CA840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DBFD9C-F2D3-4735-AE13-F0198CF4AE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3EF013-E6D1-42D9-AFF5-17CF14C5D9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FA2235-E633-4B5C-85C7-5EB6607DB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EC1AF6-7B37-47CC-91B3-D9429AD41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09F24B-E203-4433-87B0-FB46ECF01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833441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709AA-F6F4-4535-A2B5-546B36D6DE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2D1716-E774-4883-9233-CD49138B2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2A0A8A-FD2F-4AB7-A360-EBC435A42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B47F00-3FF3-4609-950B-6C04D19BF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278582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F765B8-F3B0-4CF1-9B0F-414A88A55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F3C98E-F1BA-4ED2-86DB-69FA8F528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E54142-BBDC-424C-A8B9-10044FB15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417200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B8A12-7D56-4EA3-AB8C-10F6BEA8E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D0D45-FD3E-4FB8-9316-C5F05FE11F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935BA6-0E03-473F-9109-CCD8F48226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E60E3F-E4FF-475C-BDED-0BB57E65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B77BAC-5C46-4BED-B3A3-F7437085E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7B397F-6535-4F85-B876-DA32890A8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092139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7717E-6B86-420E-AE31-951EF6FC2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6F5CCB-B796-422B-A812-221290580F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FA4402-3351-4341-9292-7017AE241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CC5BE1-393F-4C3F-9DC8-6F831FC83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A1053-93BC-4DDD-A05A-C375926E7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F979B3-BBC0-4E19-9191-F02D8CEBC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253711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AC459D-E45F-47DD-B0DB-9D95CB5DB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229B6D-A326-4172-BCE1-37EBBF5CC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AD2BA-F74E-4F40-A0EA-033B9C5D32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428E1-7756-4A77-9E48-6D71E3D7F202}" type="datetimeFigureOut">
              <a:rPr lang="en-CH" smtClean="0"/>
              <a:t>07/11/2019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0B5391-9CD3-4343-B173-2ADC1AA852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F8808-FDCC-4DA1-84A5-592A18C781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ADA54-F60F-44DB-BCDD-0AB1E8FA4DBA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534070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32638" y="1897911"/>
          <a:ext cx="10834577" cy="40233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54266">
                  <a:extLst>
                    <a:ext uri="{9D8B030D-6E8A-4147-A177-3AD203B41FA5}">
                      <a16:colId xmlns:a16="http://schemas.microsoft.com/office/drawing/2014/main" val="47727976"/>
                    </a:ext>
                  </a:extLst>
                </a:gridCol>
                <a:gridCol w="9380311">
                  <a:extLst>
                    <a:ext uri="{9D8B030D-6E8A-4147-A177-3AD203B41FA5}">
                      <a16:colId xmlns:a16="http://schemas.microsoft.com/office/drawing/2014/main" val="1452130862"/>
                    </a:ext>
                  </a:extLst>
                </a:gridCol>
              </a:tblGrid>
              <a:tr h="2464889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 6</a:t>
                      </a:r>
                    </a:p>
                  </a:txBody>
                  <a:tcPr marL="68580" marR="68580" marT="0" marB="0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 of two 1-hour Poincaré plots from a single dog showing two different hours of the day. Each hour is coded with a different color (grey and green). During different hours of the day the pattern of sinus arrhythmia represented by the beat-to-beat intervals can change within dog. The 0900 hour coded in grey had great variability in the heart rate because of frequent changes in activity as described in the diary; therefore, this hour shows transition between the influence of sympathetic system with a faster rate versus times of returning sinus arrhythmia. This video accompanies Figure 7D. Compare animation to Figure 9 illustrating the beat-to-beat changes on the electrocardiogram of sinus arrhythmia. See figure legend for details.</a:t>
                      </a:r>
                    </a:p>
                  </a:txBody>
                  <a:tcPr marL="68580" marR="68580" marT="0" marB="0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23227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63751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54866" y="91440"/>
            <a:ext cx="2119607" cy="369332"/>
          </a:xfrm>
          <a:prstGeom prst="rect">
            <a:avLst/>
          </a:prstGeom>
          <a:noFill/>
          <a:ln>
            <a:solidFill>
              <a:srgbClr val="0000CC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0" b="1" kern="1200" dirty="0">
                <a:solidFill>
                  <a:srgbClr val="FF0000"/>
                </a:solidFill>
                <a:latin typeface="+mn-lt"/>
                <a:ea typeface="+mn-ea"/>
                <a:cs typeface="+mn-cs"/>
              </a:rPr>
              <a:t>Video 6 </a:t>
            </a:r>
            <a:r>
              <a:rPr lang="en-US" b="1" dirty="0">
                <a:solidFill>
                  <a:srgbClr val="FF0000"/>
                </a:solidFill>
              </a:rPr>
              <a:t>(Figure 7)</a:t>
            </a:r>
            <a:endParaRPr lang="en-US" sz="1800" b="1" kern="1200" dirty="0">
              <a:solidFill>
                <a:srgbClr val="FF0000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4" name="TextBox 13"/>
          <p:cNvSpPr txBox="1"/>
          <p:nvPr/>
        </p:nvSpPr>
        <p:spPr>
          <a:xfrm rot="10800000" flipV="1">
            <a:off x="5433358" y="5955952"/>
            <a:ext cx="22543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R-R Interval (ms)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184551" y="2779853"/>
            <a:ext cx="27015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R-R + 1 Interval (ms)</a:t>
            </a:r>
          </a:p>
        </p:txBody>
      </p:sp>
      <p:pic>
        <p:nvPicPr>
          <p:cNvPr id="3" name="VIDEO 6 Moise_With Figure_9D _L_05_07_2019 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3829050" y="621952"/>
            <a:ext cx="5334000" cy="533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4579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Widescreen</PresentationFormat>
  <Paragraphs>6</Paragraphs>
  <Slides>2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Des Crescenzio</dc:creator>
  <cp:lastModifiedBy>Martin Des Crescenzio</cp:lastModifiedBy>
  <cp:revision>1</cp:revision>
  <dcterms:created xsi:type="dcterms:W3CDTF">2019-11-07T15:42:19Z</dcterms:created>
  <dcterms:modified xsi:type="dcterms:W3CDTF">2019-11-07T15:42:42Z</dcterms:modified>
</cp:coreProperties>
</file>